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5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034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760" y="192"/>
      </p:cViewPr>
      <p:guideLst>
        <p:guide orient="horz" pos="214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570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3940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755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342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4201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5983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7338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494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20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136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1429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72D6D6-013F-46F0-BA5D-16787A322A5D}" type="datetimeFigureOut">
              <a:rPr kumimoji="1" lang="ja-JP" altLang="en-US" smtClean="0"/>
              <a:t>2018/11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23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/>
          <p:cNvSpPr/>
          <p:nvPr/>
        </p:nvSpPr>
        <p:spPr>
          <a:xfrm>
            <a:off x="458009" y="5244905"/>
            <a:ext cx="830001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Palatino Linotype" panose="02040502050505030304" pitchFamily="18" charset="0"/>
              </a:rPr>
              <a:t>Figure S5. </a:t>
            </a:r>
            <a:r>
              <a:rPr lang="en-US" altLang="ja-JP" sz="1200" dirty="0">
                <a:latin typeface="Palatino Linotype" panose="02040502050505030304" pitchFamily="18" charset="0"/>
              </a:rPr>
              <a:t>Dot plot for correlation coefficients of domain combinations converted from 100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bp</a:t>
            </a:r>
            <a:r>
              <a:rPr lang="en-US" altLang="ja-JP" sz="1200" dirty="0">
                <a:latin typeface="Palatino Linotype" panose="02040502050505030304" pitchFamily="18" charset="0"/>
              </a:rPr>
              <a:t> DNA fragments and pairwise distances. (a) The pairwise distances were calculated based on the 16S rRNA sequence. The correlation coefficient was 0.4425. P &lt; 2.2e -16. (b) Domains count were converted to 0 (absence) / 1 (presence), and pairwise distances were calculated based on the 16S rRNA sequence. The correlation coefficients was 0.4775. P &lt; 2.2e -16. (c) Domains count were converted to converted to ln [number of domain + 1], and pairwise distances were calculated based on the 16S rRNA sequence. The correlation coefficients was 0.5921. P &lt; 2.2e -16. (d) The pairwise distances were calculated based on the DNA gyrase subunit B amino acid sequence. The correlation coefficients was 0.4656. P &lt; 2.2e -16.</a:t>
            </a:r>
            <a:r>
              <a:rPr lang="ja-JP" altLang="ja-JP" sz="1200">
                <a:latin typeface="Palatino Linotype" panose="02040502050505030304" pitchFamily="18" charset="0"/>
              </a:rPr>
              <a:t> </a:t>
            </a:r>
            <a:endParaRPr lang="en-US" altLang="ja-JP" sz="1200" dirty="0">
              <a:latin typeface="Palatino Linotype" panose="02040502050505030304" pitchFamily="18" charset="0"/>
              <a:cs typeface="Arial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2191879-9630-9443-AE0C-69A7688F63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3438" y="264240"/>
            <a:ext cx="7189160" cy="49806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1200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9</TotalTime>
  <Words>162</Words>
  <Application>Microsoft Macintosh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tuyama</dc:creator>
  <cp:lastModifiedBy>Yoji Igarashi</cp:lastModifiedBy>
  <cp:revision>66</cp:revision>
  <dcterms:created xsi:type="dcterms:W3CDTF">2018-05-29T05:04:22Z</dcterms:created>
  <dcterms:modified xsi:type="dcterms:W3CDTF">2018-11-26T05:12:44Z</dcterms:modified>
</cp:coreProperties>
</file>